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81AA2-F0D0-4BA7-BD86-3983807BBB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4C35B-6770-4294-A29F-5AA0C11A6E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54E49-B461-4862-AF1D-57754C0996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0CB77-9BD2-4F24-B97B-7B07656722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A3BD6-0CF7-4526-8719-7499EEBAE8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B1B3C-B23F-4587-A55C-CDA050ED93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09016-99E2-4E91-8D70-4751A18C4D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4D421-BD7E-46DB-8DA0-49AB483798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FBA99-B5C4-404A-A15B-D9128B2F89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8DF5F-AF73-4F06-B590-A7FBD743C1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DE36C-3887-4B5A-82CD-B385D51447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683E1-E066-42BF-8EEE-077D06A835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23F619-7530-474F-8CEE-8031E6403E6D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0CAC63-E5FF-43A6-B16D-2A06AE92A34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3"/>
          <p:cNvSpPr/>
          <p:nvPr/>
        </p:nvSpPr>
        <p:spPr>
          <a:xfrm>
            <a:off x="176040" y="5731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図 4" descr=""/>
          <p:cNvPicPr/>
          <p:nvPr/>
        </p:nvPicPr>
        <p:blipFill>
          <a:blip r:embed="rId1"/>
          <a:srcRect l="11814" t="12203" r="12007" b="52920"/>
          <a:stretch/>
        </p:blipFill>
        <p:spPr>
          <a:xfrm>
            <a:off x="841320" y="2004840"/>
            <a:ext cx="5554800" cy="19987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43" name="テキスト ボックス 6"/>
          <p:cNvSpPr/>
          <p:nvPr/>
        </p:nvSpPr>
        <p:spPr>
          <a:xfrm>
            <a:off x="3889440" y="4005360"/>
            <a:ext cx="58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Arial"/>
              </a:rPr>
              <a:t>#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7"/>
          <p:cNvSpPr/>
          <p:nvPr/>
        </p:nvSpPr>
        <p:spPr>
          <a:xfrm>
            <a:off x="4498920" y="4005360"/>
            <a:ext cx="58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#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8"/>
          <p:cNvSpPr/>
          <p:nvPr/>
        </p:nvSpPr>
        <p:spPr>
          <a:xfrm>
            <a:off x="5108400" y="4005360"/>
            <a:ext cx="58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#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9"/>
          <p:cNvSpPr/>
          <p:nvPr/>
        </p:nvSpPr>
        <p:spPr>
          <a:xfrm>
            <a:off x="5589720" y="4005360"/>
            <a:ext cx="75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00"/>
                </a:solidFill>
                <a:latin typeface="Arial"/>
                <a:ea typeface="Arial"/>
              </a:rPr>
              <a:t>#1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10"/>
          <p:cNvSpPr/>
          <p:nvPr/>
        </p:nvSpPr>
        <p:spPr>
          <a:xfrm rot="19559400">
            <a:off x="1726920" y="3646440"/>
            <a:ext cx="213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1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11"/>
          <p:cNvSpPr/>
          <p:nvPr/>
        </p:nvSpPr>
        <p:spPr>
          <a:xfrm>
            <a:off x="380880" y="3381480"/>
            <a:ext cx="84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右矢印 11"/>
          <p:cNvSpPr/>
          <p:nvPr/>
        </p:nvSpPr>
        <p:spPr>
          <a:xfrm>
            <a:off x="841320" y="3505320"/>
            <a:ext cx="281160" cy="118800"/>
          </a:xfrm>
          <a:prstGeom prst="rightArrow">
            <a:avLst>
              <a:gd name="adj1" fmla="val 50000"/>
              <a:gd name="adj2" fmla="val 50138"/>
            </a:avLst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3"/>
          <p:cNvSpPr/>
          <p:nvPr/>
        </p:nvSpPr>
        <p:spPr>
          <a:xfrm>
            <a:off x="1984320" y="4419720"/>
            <a:ext cx="17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TD-IP (input, p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14"/>
          <p:cNvSpPr/>
          <p:nvPr/>
        </p:nvSpPr>
        <p:spPr>
          <a:xfrm>
            <a:off x="1052640" y="4038480"/>
            <a:ext cx="799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pu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0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10"/>
          <p:cNvSpPr/>
          <p:nvPr/>
        </p:nvSpPr>
        <p:spPr>
          <a:xfrm rot="19559400">
            <a:off x="2106000" y="3646440"/>
            <a:ext cx="213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0"/>
          <p:cNvSpPr/>
          <p:nvPr/>
        </p:nvSpPr>
        <p:spPr>
          <a:xfrm rot="19559400">
            <a:off x="2488680" y="3619080"/>
            <a:ext cx="2132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0"/>
          <p:cNvSpPr/>
          <p:nvPr/>
        </p:nvSpPr>
        <p:spPr>
          <a:xfrm rot="19559400">
            <a:off x="2793600" y="3619440"/>
            <a:ext cx="213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0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0"/>
          <p:cNvSpPr/>
          <p:nvPr/>
        </p:nvSpPr>
        <p:spPr>
          <a:xfrm rot="19559400">
            <a:off x="3157200" y="3494160"/>
            <a:ext cx="213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19"/>
          <p:cNvSpPr/>
          <p:nvPr/>
        </p:nvSpPr>
        <p:spPr>
          <a:xfrm>
            <a:off x="1984320" y="4419720"/>
            <a:ext cx="16002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8"/>
          <p:cNvSpPr/>
          <p:nvPr/>
        </p:nvSpPr>
        <p:spPr>
          <a:xfrm>
            <a:off x="351000" y="4952880"/>
            <a:ext cx="6119640" cy="37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4. Detection of Vpr in blood samples of HIV-1-positive patients. To estimate concentration of Vpr in patients’ blood, standard IP samples were prepared and analyzed. Briefly, serum of healthy donor was diluted to 2-fold with phosphate buffer saline (PBS) (-) for decreasing the stickiness of serum. Then, 3170, 1000, 317, 100 pg of rVpr was mixed into the serum samples (STD: standard). For immunoprecipitation of Vpr, 8D1 coupled with CNBr sepharose (GE) beads were mixed with 30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L of 2-fold diluted serum samples with each standard rVpr, and incubated over-night on rotating platform at 4°C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in the presence of protease inhibitors. On the next day, the beads were washed first by PBS(-) to eliminate residual viral particles, followed by washing three times by PBS(-) supplemented with 0.5% NP40. Then, the beads were resuspended in a Laemmli sample buffer. After boiling, the samples were loaded to SDS-PAGE gel. For WB analysis, 8D1 was used as a primary antibo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rrowhead indicates Vpr-derived signal detected in patient no. 15, the intensity of which was comparable to that of 1000 pg of STD rVpr. In this experiment, 150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L of serum was subjected to the analysis, suggesting that the estimated concentration of serum Vpr is approximately 5 ng/mL. In patient no. 4, a signal with slightly smaller molecular weight band was detected, implicating the presence of mutated Vp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二等辺三角形 20"/>
          <p:cNvSpPr/>
          <p:nvPr/>
        </p:nvSpPr>
        <p:spPr>
          <a:xfrm rot="16200000">
            <a:off x="6093720" y="3383640"/>
            <a:ext cx="142560" cy="1443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46:24Z</dcterms:modified>
  <cp:revision>1632</cp:revision>
  <dc:subject/>
  <dc:title>スライド 1</dc:title>
</cp:coreProperties>
</file>